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charts/chartEx3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rts/chartEx4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ppt/charts/chartEx5.xml" ContentType="application/vnd.ms-office.chartex+xml"/>
  <Override PartName="/ppt/charts/style5.xml" ContentType="application/vnd.ms-office.chartstyle+xml"/>
  <Override PartName="/ppt/charts/colors5.xml" ContentType="application/vnd.ms-office.chartcolorstyle+xml"/>
  <Override PartName="/ppt/charts/chartEx6.xml" ContentType="application/vnd.ms-office.chartex+xml"/>
  <Override PartName="/ppt/charts/style6.xml" ContentType="application/vnd.ms-office.chartstyle+xml"/>
  <Override PartName="/ppt/charts/colors6.xml" ContentType="application/vnd.ms-office.chartcolorstyle+xml"/>
  <Override PartName="/ppt/charts/chartEx7.xml" ContentType="application/vnd.ms-office.chartex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351" r:id="rId2"/>
    <p:sldId id="344" r:id="rId3"/>
    <p:sldId id="353" r:id="rId4"/>
    <p:sldId id="354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E79"/>
    <a:srgbClr val="D883FF"/>
    <a:srgbClr val="0432FF"/>
    <a:srgbClr val="FF9DDC"/>
    <a:srgbClr val="F0BEC1"/>
    <a:srgbClr val="FF40FF"/>
    <a:srgbClr val="00FDFF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555"/>
    <p:restoredTop sz="97374"/>
  </p:normalViewPr>
  <p:slideViewPr>
    <p:cSldViewPr snapToGrid="0" snapToObjects="1">
      <p:cViewPr>
        <p:scale>
          <a:sx n="66" d="100"/>
          <a:sy n="66" d="100"/>
        </p:scale>
        <p:origin x="3264" y="5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\\Users\momoko\Desktop\2021YW\20211129\boxplot.xlsx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\\Users\momoko\Desktop\2021YW\20211129\boxplot.xlsx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\\Users\momoko\Desktop\2021YW\20211129\boxplot.xlsx" TargetMode="External"/></Relationships>
</file>

<file path=ppt/charts/_rels/chartEx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\\Users\momoko\Desktop\2021YW\20211129\boxplot.xlsx" TargetMode="External"/></Relationships>
</file>

<file path=ppt/charts/_rels/chartEx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file:///\\Users\momoko\Desktop\2021YW\20211129\boxplot.xlsx" TargetMode="External"/></Relationships>
</file>

<file path=ppt/charts/_rels/chartEx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file:///\\Users\momoko\Desktop\2021YW\20211129\boxplot.xlsx" TargetMode="External"/></Relationships>
</file>

<file path=ppt/charts/_rels/chartEx7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microsoft.com/office/2011/relationships/chartStyle" Target="style7.xml"/><Relationship Id="rId1" Type="http://schemas.openxmlformats.org/officeDocument/2006/relationships/oleObject" Target="file:///\\Users\momoko\Desktop\2021YW\20211129\boxplot.xlsx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'20220929'!$C$2:$G$2</cx:f>
        <cx:lvl ptCount="5" formatCode="G/標準">
          <cx:pt idx="0">1214.1407826156201</cx:pt>
          <cx:pt idx="1">932.30293595149897</cx:pt>
          <cx:pt idx="2">1263.67521515406</cx:pt>
          <cx:pt idx="3">1090.9127456312999</cx:pt>
        </cx:lvl>
      </cx:numDim>
    </cx:data>
    <cx:data id="1">
      <cx:numDim type="val">
        <cx:f dir="row">Sheet1!$C$3:$G$3</cx:f>
        <cx:lvl ptCount="5" formatCode="G/標準">
          <cx:pt idx="0">677.90720780142794</cx:pt>
          <cx:pt idx="1">575.50673432116298</cx:pt>
          <cx:pt idx="2">862.78064365206501</cx:pt>
          <cx:pt idx="3">717.72929646715704</cx:pt>
          <cx:pt idx="4">720.89483374380302</cx:pt>
        </cx:lvl>
      </cx:numDim>
    </cx:data>
    <cx:data id="2">
      <cx:numDim type="val">
        <cx:f dir="row">Sheet1!$C$4:$G$4</cx:f>
        <cx:lvl ptCount="5" formatCode="G/標準">
          <cx:pt idx="0">786.31033140944498</cx:pt>
          <cx:pt idx="1">928.60098435768805</cx:pt>
          <cx:pt idx="2">725.37539541890305</cx:pt>
          <cx:pt idx="3">975.52700464272402</cx:pt>
          <cx:pt idx="4">948.04123486705203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i="1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400" b="0" i="1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     Elk1</a:t>
            </a:r>
            <a:endParaRPr lang="ja-JP" altLang="en-US" sz="1400" b="0" i="1" u="none" strike="noStrike" baseline="0">
              <a:solidFill>
                <a:schemeClr val="tx1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cx:rich>
      </cx:tx>
    </cx:title>
    <cx:plotArea>
      <cx:plotAreaRegion>
        <cx:plotSurface>
          <cx:spPr>
            <a:ln>
              <a:solidFill>
                <a:schemeClr val="tx1"/>
              </a:solidFill>
            </a:ln>
          </cx:spPr>
        </cx:plotSurface>
        <cx:series layoutId="boxWhisker" uniqueId="{C0A2E69C-03B2-FB4C-808C-34550D96A733}">
          <cx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meanLine="0" meanMarker="1" nonoutliers="0" outliers="1"/>
            <cx:statistics quartileMethod="exclusive"/>
          </cx:layoutPr>
        </cx:series>
        <cx:series layoutId="boxWhisker" uniqueId="{E9D90143-7396-7C47-B83A-FFD52781FD7E}">
          <cx:spPr>
            <a:solidFill>
              <a:srgbClr val="FF7E79"/>
            </a:solidFill>
            <a:ln>
              <a:solidFill>
                <a:schemeClr val="tx1"/>
              </a:solidFill>
            </a:ln>
          </cx:spPr>
          <cx:dataId val="1"/>
          <cx:layoutPr>
            <cx:visibility meanLine="0" meanMarker="1" nonoutliers="0" outliers="1"/>
            <cx:statistics quartileMethod="exclusive"/>
          </cx:layoutPr>
        </cx:series>
        <cx:series layoutId="boxWhisker" uniqueId="{699F0D0D-E796-9345-947B-4D1F6CA58832}">
          <cx:spPr>
            <a:solidFill>
              <a:srgbClr val="FF0000"/>
            </a:solidFill>
            <a:ln>
              <a:solidFill>
                <a:schemeClr val="tx1"/>
              </a:solidFill>
            </a:ln>
          </cx:spPr>
          <cx:dataId val="2"/>
          <cx:layoutPr>
            <cx:visibility meanLine="0" meanMarker="1" nonoutliers="0" outliers="1"/>
            <cx:statistics quartileMethod="ex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tickLabels/>
        <cx:txPr>
          <a:bodyPr vertOverflow="overflow" horzOverflow="overflow" wrap="square" lIns="0" tIns="0" rIns="0" bIns="0"/>
          <a:lstStyle/>
          <a:p>
            <a:pPr algn="ctr" rtl="0">
              <a:defRPr sz="11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1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'20220929'!$C$19:$G$19</cx:f>
        <cx:lvl ptCount="5" formatCode="G/標準">
          <cx:pt idx="0">35847.875483398799</cx:pt>
          <cx:pt idx="1">30407.508696892601</cx:pt>
          <cx:pt idx="2">27914.1692413889</cx:pt>
          <cx:pt idx="3">29672.317711346899</cx:pt>
        </cx:lvl>
      </cx:numDim>
    </cx:data>
    <cx:data id="1">
      <cx:numDim type="val">
        <cx:f dir="row">'20220929'!$C$20:$G$20</cx:f>
        <cx:lvl ptCount="5" formatCode="G/標準">
          <cx:pt idx="0">29562.0766965441</cx:pt>
          <cx:pt idx="1">30809.763763896099</cx:pt>
          <cx:pt idx="2">45666.544265009798</cx:pt>
          <cx:pt idx="3">38984.418643469697</cx:pt>
          <cx:pt idx="4">36344.010327185897</cx:pt>
        </cx:lvl>
      </cx:numDim>
    </cx:data>
    <cx:data id="2">
      <cx:numDim type="val">
        <cx:f dir="row">'20220929'!$C$21:$G$21</cx:f>
        <cx:lvl ptCount="5" formatCode="G/標準">
          <cx:pt idx="0">17299.707202401401</cx:pt>
          <cx:pt idx="1">23122.984514781299</cx:pt>
          <cx:pt idx="2">34177.517747828497</cx:pt>
          <cx:pt idx="3">16497.159265549701</cx:pt>
          <cx:pt idx="4">22340.4403119585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i="1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400" b="0" i="1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     Egr1</a:t>
            </a:r>
            <a:endParaRPr lang="ja-JP" altLang="en-US" sz="1400" b="0" i="1" u="none" strike="noStrike" baseline="0">
              <a:solidFill>
                <a:schemeClr val="tx1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cx:rich>
      </cx:tx>
    </cx:title>
    <cx:plotArea>
      <cx:plotAreaRegion>
        <cx:plotSurface>
          <cx:spPr>
            <a:ln>
              <a:solidFill>
                <a:schemeClr val="tx1"/>
              </a:solidFill>
            </a:ln>
          </cx:spPr>
        </cx:plotSurface>
        <cx:series layoutId="boxWhisker" uniqueId="{003B58F9-003A-2B48-8862-EDAF15B7E0CB}">
          <cx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statistics quartileMethod="exclusive"/>
          </cx:layoutPr>
        </cx:series>
        <cx:series layoutId="boxWhisker" uniqueId="{147F01AC-93AF-2743-BE31-9FCDA41ABED2}">
          <cx:spPr>
            <a:solidFill>
              <a:srgbClr val="FF7E79"/>
            </a:solidFill>
            <a:ln>
              <a:solidFill>
                <a:schemeClr val="tx1"/>
              </a:solidFill>
            </a:ln>
          </cx:spPr>
          <cx:dataId val="1"/>
          <cx:layoutPr>
            <cx:visibility nonoutliers="0" outliers="0"/>
            <cx:statistics quartileMethod="exclusive"/>
          </cx:layoutPr>
        </cx:series>
        <cx:series layoutId="boxWhisker" uniqueId="{4ACD618F-ECAE-C94F-833D-309FA596FC4F}">
          <cx:spPr>
            <a:solidFill>
              <a:srgbClr val="FF0000"/>
            </a:solidFill>
            <a:ln>
              <a:solidFill>
                <a:schemeClr val="tx1"/>
              </a:solidFill>
            </a:ln>
          </cx:spPr>
          <cx:dataId val="2"/>
          <cx:layoutPr>
            <cx:statistics quartileMethod="ex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tickLabels/>
        <cx:txPr>
          <a:bodyPr vertOverflow="overflow" horzOverflow="overflow" wrap="square" lIns="0" tIns="0" rIns="0" bIns="0"/>
          <a:lstStyle/>
          <a:p>
            <a:pPr algn="ctr" rtl="0">
              <a:defRPr sz="11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1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'20220929'!$J$37:$N$37</cx:f>
        <cx:lvl ptCount="5" formatCode="G/標準">
          <cx:pt idx="0">479.3886692941</cx:pt>
          <cx:pt idx="1">397.73066834423901</cx:pt>
          <cx:pt idx="2">588.96332933317399</cx:pt>
          <cx:pt idx="3">350.00555274815702</cx:pt>
        </cx:lvl>
      </cx:numDim>
    </cx:data>
    <cx:data id="1">
      <cx:numDim type="val">
        <cx:f dir="row">'20220929'!$J$38:$N$38</cx:f>
        <cx:lvl ptCount="5" formatCode="G/標準">
          <cx:pt idx="0">489.67712748352301</cx:pt>
          <cx:pt idx="1">238.37762247678799</cx:pt>
          <cx:pt idx="2">433.96323087542402</cx:pt>
          <cx:pt idx="3">476.964142408025</cx:pt>
          <cx:pt idx="4">549.58697385026403</cx:pt>
        </cx:lvl>
      </cx:numDim>
    </cx:data>
    <cx:data id="2">
      <cx:numDim type="val">
        <cx:f dir="row">'20220929'!$J$39:$N$39</cx:f>
        <cx:lvl ptCount="5" formatCode="G/標準">
          <cx:pt idx="0">302.542078361037</cx:pt>
          <cx:pt idx="1">325.00858122503098</cx:pt>
          <cx:pt idx="2">499.223486951761</cx:pt>
          <cx:pt idx="3">213.86031747011401</cx:pt>
          <cx:pt idx="4">300.26614291639902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i="1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400" b="0" i="1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     Ptgs2</a:t>
            </a:r>
            <a:endParaRPr lang="ja-JP" altLang="en-US" sz="1400" b="0" i="1" u="none" strike="noStrike" baseline="0">
              <a:solidFill>
                <a:schemeClr val="tx1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cx:rich>
      </cx:tx>
    </cx:title>
    <cx:plotArea>
      <cx:plotAreaRegion>
        <cx:plotSurface>
          <cx:spPr>
            <a:ln>
              <a:solidFill>
                <a:schemeClr val="tx1"/>
              </a:solidFill>
            </a:ln>
          </cx:spPr>
        </cx:plotSurface>
        <cx:series layoutId="boxWhisker" uniqueId="{1644C08E-360D-814C-837B-F234FF76EF19}">
          <cx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nonoutliers="0" outliers="0"/>
            <cx:statistics quartileMethod="exclusive"/>
          </cx:layoutPr>
        </cx:series>
        <cx:series layoutId="boxWhisker" uniqueId="{59D4F883-38FF-5542-969F-706B63CD8ADF}">
          <cx:spPr>
            <a:solidFill>
              <a:srgbClr val="FF7E79"/>
            </a:solidFill>
            <a:ln>
              <a:solidFill>
                <a:schemeClr val="tx1"/>
              </a:solidFill>
            </a:ln>
          </cx:spPr>
          <cx:dataId val="1"/>
          <cx:layoutPr>
            <cx:visibility nonoutliers="0" outliers="0"/>
            <cx:statistics quartileMethod="exclusive"/>
          </cx:layoutPr>
        </cx:series>
        <cx:series layoutId="boxWhisker" uniqueId="{393B433F-F2BB-B04B-88D7-9730925A21C6}">
          <cx:spPr>
            <a:solidFill>
              <a:srgbClr val="FF0000"/>
            </a:solidFill>
            <a:ln>
              <a:solidFill>
                <a:schemeClr val="tx1"/>
              </a:solidFill>
            </a:ln>
          </cx:spPr>
          <cx:dataId val="2"/>
          <cx:layoutPr>
            <cx:visibility nonoutliers="0" outliers="0"/>
            <cx:statistics quartileMethod="ex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tickLabels/>
        <cx:txPr>
          <a:bodyPr vertOverflow="overflow" horzOverflow="overflow" wrap="square" lIns="0" tIns="0" rIns="0" bIns="0"/>
          <a:lstStyle/>
          <a:p>
            <a:pPr algn="ctr" rtl="0">
              <a:defRPr sz="11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1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'20220929'!$J$53:$N$53</cx:f>
        <cx:lvl ptCount="5" formatCode="G/標準">
          <cx:pt idx="0">130.475036922996</cx:pt>
          <cx:pt idx="1">102.602352522863</cx:pt>
          <cx:pt idx="2">132.04977197315</cx:pt>
          <cx:pt idx="3">131.73701904766699</cx:pt>
        </cx:lvl>
      </cx:numDim>
    </cx:data>
    <cx:data id="1">
      <cx:numDim type="val">
        <cx:f dir="row">'20220929'!$J$54:$N$54</cx:f>
        <cx:lvl ptCount="5" formatCode="G/標準">
          <cx:pt idx="0">180.08959261227099</cx:pt>
          <cx:pt idx="1">170.22014793035501</cx:pt>
          <cx:pt idx="2">158.88542740968401</cx:pt>
          <cx:pt idx="3">147.38286565306501</cx:pt>
          <cx:pt idx="4">148.095603306226</cx:pt>
        </cx:lvl>
      </cx:numDim>
    </cx:data>
    <cx:data id="2">
      <cx:numDim type="val">
        <cx:f dir="row">'20220929'!$J$55:$N$55</cx:f>
        <cx:lvl ptCount="5" formatCode="G/標準">
          <cx:pt idx="0">131.878996124027</cx:pt>
          <cx:pt idx="1">120.156592901371</cx:pt>
          <cx:pt idx="2">154.43168790748101</cx:pt>
          <cx:pt idx="3">166.55409324540099</cx:pt>
          <cx:pt idx="4">162.03616104087899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i="1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400" b="0" i="1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     Pxn</a:t>
            </a:r>
            <a:endParaRPr lang="ja-JP" altLang="en-US" sz="1400" b="0" i="1" u="none" strike="noStrike" baseline="0">
              <a:solidFill>
                <a:schemeClr val="tx1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cx:rich>
      </cx:tx>
    </cx:title>
    <cx:plotArea>
      <cx:plotAreaRegion>
        <cx:plotSurface>
          <cx:spPr>
            <a:ln>
              <a:solidFill>
                <a:schemeClr val="tx1"/>
              </a:solidFill>
            </a:ln>
          </cx:spPr>
        </cx:plotSurface>
        <cx:series layoutId="boxWhisker" uniqueId="{8ED03A2C-0C55-394A-88D1-E16EF375C4A9}">
          <cx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nonoutliers="0" outliers="0"/>
            <cx:statistics quartileMethod="exclusive"/>
          </cx:layoutPr>
        </cx:series>
        <cx:series layoutId="boxWhisker" uniqueId="{2828F0A4-2DA2-A54C-9DB3-62CD812E3DBE}">
          <cx:spPr>
            <a:solidFill>
              <a:srgbClr val="FF7E79"/>
            </a:solidFill>
            <a:ln>
              <a:solidFill>
                <a:schemeClr val="tx1"/>
              </a:solidFill>
            </a:ln>
          </cx:spPr>
          <cx:dataId val="1"/>
          <cx:layoutPr>
            <cx:visibility nonoutliers="0" outliers="0"/>
            <cx:statistics quartileMethod="exclusive"/>
          </cx:layoutPr>
        </cx:series>
        <cx:series layoutId="boxWhisker" uniqueId="{185C5B11-DFE6-404C-9D36-2D15A778DCFC}">
          <cx:spPr>
            <a:solidFill>
              <a:srgbClr val="FF0000"/>
            </a:solidFill>
            <a:ln>
              <a:solidFill>
                <a:schemeClr val="tx1"/>
              </a:solidFill>
            </a:ln>
          </cx:spPr>
          <cx:dataId val="2"/>
          <cx:layoutPr>
            <cx:visibility nonoutliers="0" outliers="0"/>
            <cx:statistics quartileMethod="ex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tickLabels/>
        <cx:txPr>
          <a:bodyPr vertOverflow="overflow" horzOverflow="overflow" wrap="square" lIns="0" tIns="0" rIns="0" bIns="0"/>
          <a:lstStyle/>
          <a:p>
            <a:pPr algn="ctr" rtl="0">
              <a:defRPr sz="11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1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'20220929'!$C$69:$G$69</cx:f>
        <cx:lvl ptCount="5" formatCode="G/標準">
          <cx:pt idx="0">433.46599211843801</cx:pt>
          <cx:pt idx="1">625.75842509643905</cx:pt>
          <cx:pt idx="2">716.59442032587401</cx:pt>
          <cx:pt idx="3">496.14706191465899</cx:pt>
        </cx:lvl>
      </cx:numDim>
    </cx:data>
    <cx:data id="1">
      <cx:numDim type="val">
        <cx:f dir="row">'20220929'!$C$70:$G$70</cx:f>
        <cx:lvl ptCount="5" formatCode="G/標準">
          <cx:pt idx="0">765.02760699163696</cx:pt>
          <cx:pt idx="1">710.85820317396497</cx:pt>
          <cx:pt idx="2">654.90053527756902</cx:pt>
          <cx:pt idx="3">831.12346624887903</cx:pt>
          <cx:pt idx="4">945.54217538620503</cx:pt>
        </cx:lvl>
      </cx:numDim>
    </cx:data>
    <cx:data id="2">
      <cx:numDim type="val">
        <cx:f dir="row">'20220929'!$C$71:$G$71</cx:f>
        <cx:lvl ptCount="5" formatCode="G/標準">
          <cx:pt idx="0">540.33787461131101</cx:pt>
          <cx:pt idx="1">728.61051228660097</cx:pt>
          <cx:pt idx="2">799.55363255604095</cx:pt>
          <cx:pt idx="3">667.97578785632595</cx:pt>
          <cx:pt idx="4">616.999709547007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i="1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400" b="0" i="1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     Bcar1</a:t>
            </a:r>
            <a:endParaRPr lang="ja-JP" altLang="en-US" sz="1400" b="0" i="1" u="none" strike="noStrike" baseline="0">
              <a:solidFill>
                <a:schemeClr val="tx1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cx:rich>
      </cx:tx>
    </cx:title>
    <cx:plotArea>
      <cx:plotAreaRegion>
        <cx:plotSurface>
          <cx:spPr>
            <a:ln>
              <a:solidFill>
                <a:schemeClr val="tx1"/>
              </a:solidFill>
            </a:ln>
          </cx:spPr>
        </cx:plotSurface>
        <cx:series layoutId="boxWhisker" uniqueId="{42713ECE-50C2-9342-BE9C-D191C9411D39}">
          <cx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nonoutliers="0" outliers="0"/>
            <cx:statistics quartileMethod="exclusive"/>
          </cx:layoutPr>
        </cx:series>
        <cx:series layoutId="boxWhisker" uniqueId="{7C645DF4-2878-9F48-AD96-CD3567218D54}">
          <cx:spPr>
            <a:solidFill>
              <a:srgbClr val="FF7E79"/>
            </a:solidFill>
            <a:ln>
              <a:solidFill>
                <a:schemeClr val="tx1"/>
              </a:solidFill>
            </a:ln>
          </cx:spPr>
          <cx:dataId val="1"/>
          <cx:layoutPr>
            <cx:visibility nonoutliers="0" outliers="0"/>
            <cx:statistics quartileMethod="exclusive"/>
          </cx:layoutPr>
        </cx:series>
        <cx:series layoutId="boxWhisker" uniqueId="{80755A10-EB4A-764B-94D5-70CD3368F47F}">
          <cx:spPr>
            <a:solidFill>
              <a:srgbClr val="FF0000"/>
            </a:solidFill>
            <a:ln>
              <a:solidFill>
                <a:schemeClr val="tx1"/>
              </a:solidFill>
            </a:ln>
          </cx:spPr>
          <cx:dataId val="2"/>
          <cx:layoutPr>
            <cx:visibility nonoutliers="0" outliers="0"/>
            <cx:statistics quartileMethod="ex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tickLabels/>
        <cx:txPr>
          <a:bodyPr vertOverflow="overflow" horzOverflow="overflow" wrap="square" lIns="0" tIns="0" rIns="0" bIns="0"/>
          <a:lstStyle/>
          <a:p>
            <a:pPr algn="ctr" rtl="0">
              <a:defRPr sz="11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1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6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'20220929'!$J$69:$N$69</cx:f>
        <cx:lvl ptCount="5" formatCode="G/標準">
          <cx:pt idx="0">9934.3509616600004</cx:pt>
          <cx:pt idx="1">8512.5166522464606</cx:pt>
          <cx:pt idx="2">9242.2602554446803</cx:pt>
          <cx:pt idx="3">7580.0938744860796</cx:pt>
        </cx:lvl>
      </cx:numDim>
    </cx:data>
    <cx:data id="1">
      <cx:numDim type="val">
        <cx:f dir="row">'20220929'!$J$70:$N$70</cx:f>
        <cx:lvl ptCount="5" formatCode="G/標準">
          <cx:pt idx="0">10181.0589073925</cx:pt>
          <cx:pt idx="1">7177.9691136333904</cx:pt>
          <cx:pt idx="2">8575.2320707224007</cx:pt>
          <cx:pt idx="3">9389.6782012186795</cx:pt>
          <cx:pt idx="4">9234.3839301203698</cx:pt>
        </cx:lvl>
      </cx:numDim>
    </cx:data>
    <cx:data id="2">
      <cx:numDim type="val">
        <cx:f dir="row">'20220929'!$J$71:$N$71</cx:f>
        <cx:lvl ptCount="5" formatCode="G/標準">
          <cx:pt idx="0">6038.8578578398001</cx:pt>
          <cx:pt idx="1">8793.3062504141108</cx:pt>
          <cx:pt idx="2">8151.8963914967499</cx:pt>
          <cx:pt idx="3">6888.9099295105598</cx:pt>
          <cx:pt idx="4">8190.1263879298003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i="1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400" b="0" i="1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     Ptk2</a:t>
            </a:r>
            <a:endParaRPr lang="ja-JP" altLang="en-US" sz="1400" b="0" i="1" u="none" strike="noStrike" baseline="0">
              <a:solidFill>
                <a:schemeClr val="tx1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cx:rich>
      </cx:tx>
    </cx:title>
    <cx:plotArea>
      <cx:plotAreaRegion>
        <cx:plotSurface>
          <cx:spPr>
            <a:ln>
              <a:solidFill>
                <a:schemeClr val="tx1"/>
              </a:solidFill>
            </a:ln>
          </cx:spPr>
        </cx:plotSurface>
        <cx:series layoutId="boxWhisker" uniqueId="{EF1F6B0F-5767-2D42-967F-E7092DADA69D}">
          <cx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nonoutliers="0" outliers="0"/>
            <cx:statistics quartileMethod="exclusive"/>
          </cx:layoutPr>
        </cx:series>
        <cx:series layoutId="boxWhisker" uniqueId="{BF5F6442-7337-A447-8FB1-DD4A61C1DF9E}">
          <cx:spPr>
            <a:solidFill>
              <a:srgbClr val="FF7E79"/>
            </a:solidFill>
            <a:ln>
              <a:solidFill>
                <a:schemeClr val="tx1"/>
              </a:solidFill>
            </a:ln>
          </cx:spPr>
          <cx:dataId val="1"/>
          <cx:layoutPr>
            <cx:visibility nonoutliers="0" outliers="0"/>
            <cx:statistics quartileMethod="exclusive"/>
          </cx:layoutPr>
        </cx:series>
        <cx:series layoutId="boxWhisker" uniqueId="{5774132F-39E6-4845-A9D5-9405406A1960}">
          <cx:spPr>
            <a:solidFill>
              <a:srgbClr val="FF0000"/>
            </a:solidFill>
            <a:ln>
              <a:solidFill>
                <a:schemeClr val="tx1"/>
              </a:solidFill>
            </a:ln>
          </cx:spPr>
          <cx:dataId val="2"/>
          <cx:layoutPr>
            <cx:visibility nonoutliers="0" outliers="0"/>
            <cx:statistics quartileMethod="ex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tickLabels/>
        <cx:txPr>
          <a:bodyPr vertOverflow="overflow" horzOverflow="overflow" wrap="square" lIns="0" tIns="0" rIns="0" bIns="0"/>
          <a:lstStyle/>
          <a:p>
            <a:pPr algn="ctr" rtl="0">
              <a:defRPr sz="11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1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7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'20220929'!$J$19:$N$19</cx:f>
        <cx:lvl ptCount="5" formatCode="G/標準">
          <cx:pt idx="0">130678.293989019</cx:pt>
          <cx:pt idx="1">86558.027338426196</cx:pt>
          <cx:pt idx="2">122526.136239416</cx:pt>
          <cx:pt idx="3">84628.149487492497</cx:pt>
        </cx:lvl>
      </cx:numDim>
    </cx:data>
    <cx:data id="1">
      <cx:numDim type="val">
        <cx:f dir="row">'20220929'!$J$20:$N$20</cx:f>
        <cx:lvl ptCount="5" formatCode="G/標準">
          <cx:pt idx="0">137436.91188476299</cx:pt>
          <cx:pt idx="1">112831.47136033099</cx:pt>
          <cx:pt idx="2">126950.803448048</cx:pt>
          <cx:pt idx="3">150425.53893402399</cx:pt>
          <cx:pt idx="4">143929.22128869599</cx:pt>
        </cx:lvl>
      </cx:numDim>
    </cx:data>
    <cx:data id="2">
      <cx:numDim type="val">
        <cx:f dir="row">'20220929'!$J$21:$N$21</cx:f>
        <cx:lvl ptCount="5" formatCode="G/標準">
          <cx:pt idx="0">97293.108588510193</cx:pt>
          <cx:pt idx="1">118968.49113088301</cx:pt>
          <cx:pt idx="2">128747.955757569</cx:pt>
          <cx:pt idx="3">109875.484390596</cx:pt>
          <cx:pt idx="4">102607.737427802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i="1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400" b="0" i="1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Cck</a:t>
            </a:r>
            <a:endParaRPr lang="ja-JP" altLang="en-US" sz="1400" b="0" i="1" u="none" strike="noStrike" baseline="0">
              <a:solidFill>
                <a:schemeClr val="tx1"/>
              </a:solidFill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cx:rich>
      </cx:tx>
    </cx:title>
    <cx:plotArea>
      <cx:plotAreaRegion>
        <cx:plotSurface>
          <cx:spPr>
            <a:ln>
              <a:solidFill>
                <a:schemeClr val="tx1"/>
              </a:solidFill>
            </a:ln>
          </cx:spPr>
        </cx:plotSurface>
        <cx:series layoutId="boxWhisker" uniqueId="{336DABBE-FDC6-074B-9CB5-D4A3DB140BEC}">
          <cx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x:spPr>
          <cx:dataId val="0"/>
          <cx:layoutPr>
            <cx:visibility nonoutliers="0" outliers="0"/>
            <cx:statistics quartileMethod="exclusive"/>
          </cx:layoutPr>
        </cx:series>
        <cx:series layoutId="boxWhisker" uniqueId="{F5A5AA03-9775-3340-AF61-375DA1A2CB16}">
          <cx:spPr>
            <a:solidFill>
              <a:srgbClr val="FF7E79"/>
            </a:solidFill>
            <a:ln>
              <a:solidFill>
                <a:schemeClr val="tx1"/>
              </a:solidFill>
            </a:ln>
          </cx:spPr>
          <cx:dataId val="1"/>
          <cx:layoutPr>
            <cx:visibility nonoutliers="0" outliers="0"/>
            <cx:statistics quartileMethod="exclusive"/>
          </cx:layoutPr>
        </cx:series>
        <cx:series layoutId="boxWhisker" uniqueId="{BDA54B00-0AAF-764E-9A18-7F7BA3F5DA1F}">
          <cx:spPr>
            <a:solidFill>
              <a:srgbClr val="FF0000"/>
            </a:solidFill>
            <a:ln>
              <a:solidFill>
                <a:schemeClr val="tx1"/>
              </a:solidFill>
            </a:ln>
          </cx:spPr>
          <cx:dataId val="2"/>
          <cx:layoutPr>
            <cx:visibility nonoutliers="0" outliers="0"/>
            <cx:statistics quartileMethod="exclusive"/>
          </cx:layoutPr>
        </cx:series>
      </cx:plotAreaRegion>
      <cx:axis id="0" hidden="1">
        <cx:catScaling gapWidth="1"/>
        <cx:tickLabels/>
        <cx:txPr>
          <a:bodyPr vertOverflow="overflow" horzOverflow="overflow" wrap="square" lIns="0" tIns="0" rIns="0" bIns="0"/>
          <a:lstStyle/>
          <a:p>
            <a:pPr algn="ctr" rtl="0">
              <a:defRPr sz="9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tickLabels/>
        <cx:txPr>
          <a:bodyPr vertOverflow="overflow" horzOverflow="overflow" wrap="square" lIns="0" tIns="0" rIns="0" bIns="0"/>
          <a:lstStyle/>
          <a:p>
            <a:pPr algn="ctr" rtl="0">
              <a:defRPr sz="11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1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6E01EE-42F3-AD49-A606-A0DE5DB81A24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E31663-30E4-0B40-905D-82AE14ABAA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46358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8143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1845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4031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612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3030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6848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280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3456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3824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104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2150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218CC5-C930-5843-A5DA-8E0A27D7424E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E9116-9E9D-D34D-B599-CD50F46B15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390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14/relationships/chartEx" Target="../charts/chartEx4.xml"/><Relationship Id="rId13" Type="http://schemas.openxmlformats.org/officeDocument/2006/relationships/image" Target="../media/image33.png"/><Relationship Id="rId3" Type="http://schemas.openxmlformats.org/officeDocument/2006/relationships/image" Target="../media/image28.png"/><Relationship Id="rId7" Type="http://schemas.openxmlformats.org/officeDocument/2006/relationships/image" Target="../media/image30.png"/><Relationship Id="rId12" Type="http://schemas.microsoft.com/office/2014/relationships/chartEx" Target="../charts/chartEx6.xml"/><Relationship Id="rId2" Type="http://schemas.microsoft.com/office/2014/relationships/chartEx" Target="../charts/chartEx1.xml"/><Relationship Id="rId1" Type="http://schemas.openxmlformats.org/officeDocument/2006/relationships/slideLayout" Target="../slideLayouts/slideLayout7.xml"/><Relationship Id="rId6" Type="http://schemas.microsoft.com/office/2014/relationships/chartEx" Target="../charts/chartEx3.xml"/><Relationship Id="rId11" Type="http://schemas.openxmlformats.org/officeDocument/2006/relationships/image" Target="../media/image32.png"/><Relationship Id="rId5" Type="http://schemas.openxmlformats.org/officeDocument/2006/relationships/image" Target="../media/image29.png"/><Relationship Id="rId15" Type="http://schemas.openxmlformats.org/officeDocument/2006/relationships/image" Target="../media/image34.png"/><Relationship Id="rId10" Type="http://schemas.microsoft.com/office/2014/relationships/chartEx" Target="../charts/chartEx5.xml"/><Relationship Id="rId4" Type="http://schemas.microsoft.com/office/2014/relationships/chartEx" Target="../charts/chartEx2.xml"/><Relationship Id="rId9" Type="http://schemas.openxmlformats.org/officeDocument/2006/relationships/image" Target="../media/image31.png"/><Relationship Id="rId14" Type="http://schemas.microsoft.com/office/2014/relationships/chartEx" Target="../charts/chartEx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99CEEC4-BE56-6049-2FDE-562829EEB93C}"/>
              </a:ext>
            </a:extLst>
          </p:cNvPr>
          <p:cNvSpPr txBox="1"/>
          <p:nvPr/>
        </p:nvSpPr>
        <p:spPr>
          <a:xfrm>
            <a:off x="2693077" y="30540"/>
            <a:ext cx="416492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>
                <a:latin typeface="Arial" panose="020B0604020202020204" pitchFamily="34" charset="0"/>
                <a:cs typeface="Arial" panose="020B0604020202020204" pitchFamily="34" charset="0"/>
              </a:rPr>
              <a:t>Supplementary materials</a:t>
            </a:r>
            <a:endParaRPr kumimoji="1" lang="ja-JP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0AE31E6-768F-5C52-E857-4628310F2F7B}"/>
              </a:ext>
            </a:extLst>
          </p:cNvPr>
          <p:cNvSpPr txBox="1">
            <a:spLocks/>
          </p:cNvSpPr>
          <p:nvPr/>
        </p:nvSpPr>
        <p:spPr>
          <a:xfrm>
            <a:off x="387927" y="4802717"/>
            <a:ext cx="6123709" cy="2207683"/>
          </a:xfrm>
          <a:prstGeom prst="rect">
            <a:avLst/>
          </a:prstGeom>
        </p:spPr>
        <p:txBody>
          <a:bodyPr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Momoko Hamano, Takashi Ichinose, </a:t>
            </a:r>
            <a:r>
              <a:rPr lang="en-US" altLang="ja-JP" sz="2000" dirty="0" err="1">
                <a:latin typeface="Arial" panose="020B0604020202020204" pitchFamily="34" charset="0"/>
                <a:cs typeface="Arial" panose="020B0604020202020204" pitchFamily="34" charset="0"/>
              </a:rPr>
              <a:t>Tokio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 Yasuda, </a:t>
            </a:r>
            <a:r>
              <a:rPr lang="en" altLang="ja-JP" sz="2000" dirty="0">
                <a:latin typeface="Helvetica" pitchFamily="2" charset="0"/>
              </a:rPr>
              <a:t>Tomoko </a:t>
            </a:r>
            <a:r>
              <a:rPr lang="en" altLang="ja-JP" sz="2000" dirty="0" err="1">
                <a:latin typeface="Helvetica" pitchFamily="2" charset="0"/>
              </a:rPr>
              <a:t>Ishijima</a:t>
            </a:r>
            <a:r>
              <a:rPr lang="en" altLang="ja-JP" sz="2000" dirty="0">
                <a:latin typeface="Helvetica" pitchFamily="2" charset="0"/>
              </a:rPr>
              <a:t>, Shinji Okada, Keiko Abe</a:t>
            </a:r>
            <a:r>
              <a:rPr lang="en" altLang="ja-JP" sz="2000" dirty="0">
                <a:solidFill>
                  <a:srgbClr val="202020"/>
                </a:solidFill>
                <a:latin typeface="Helvetica" pitchFamily="2" charset="0"/>
              </a:rPr>
              <a:t> 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nd Shigeki </a:t>
            </a:r>
            <a:r>
              <a:rPr lang="en-US" altLang="ja-JP" sz="2000" dirty="0" err="1">
                <a:latin typeface="Arial" panose="020B0604020202020204" pitchFamily="34" charset="0"/>
                <a:cs typeface="Arial" panose="020B0604020202020204" pitchFamily="34" charset="0"/>
              </a:rPr>
              <a:t>Furuya</a:t>
            </a:r>
            <a:endParaRPr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タイトル 6">
            <a:extLst>
              <a:ext uri="{FF2B5EF4-FFF2-40B4-BE49-F238E27FC236}">
                <a16:creationId xmlns:a16="http://schemas.microsoft.com/office/drawing/2014/main" id="{2E2BB591-1AC7-D8A1-9509-63B904785E8C}"/>
              </a:ext>
            </a:extLst>
          </p:cNvPr>
          <p:cNvSpPr txBox="1">
            <a:spLocks/>
          </p:cNvSpPr>
          <p:nvPr/>
        </p:nvSpPr>
        <p:spPr>
          <a:xfrm>
            <a:off x="248197" y="1962044"/>
            <a:ext cx="6364431" cy="3183467"/>
          </a:xfrm>
          <a:prstGeom prst="rect">
            <a:avLst/>
          </a:prstGeom>
        </p:spPr>
        <p:txBody>
          <a:bodyPr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kern="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</a:rPr>
              <a:t>Bioinformatic analysis of the molecular networks associated with amelioration of aberrant gene expression by Tyr-</a:t>
            </a:r>
            <a:r>
              <a:rPr lang="en-US" altLang="ja-JP" sz="18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</a:rPr>
              <a:t>Trp</a:t>
            </a:r>
            <a:r>
              <a:rPr lang="en-US" altLang="ja-JP" sz="1800" kern="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</a:rPr>
              <a:t> di-peptide in the brain treated with amyloid-</a:t>
            </a:r>
            <a:r>
              <a:rPr lang="el-GR" altLang="ja-JP" sz="1800" kern="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</a:rPr>
              <a:t>β </a:t>
            </a:r>
            <a:r>
              <a:rPr lang="en-US" altLang="ja-JP" sz="1800" kern="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</a:rPr>
              <a:t>peptide</a:t>
            </a:r>
            <a:br>
              <a:rPr lang="en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" altLang="ja-JP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00185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17ED707-1C1F-D848-A59F-38BEE721F082}"/>
              </a:ext>
            </a:extLst>
          </p:cNvPr>
          <p:cNvSpPr txBox="1"/>
          <p:nvPr/>
        </p:nvSpPr>
        <p:spPr>
          <a:xfrm>
            <a:off x="0" y="0"/>
            <a:ext cx="412324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 Supplementary table S1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CFDC4004-E24A-3548-AD0B-90507FB10D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9187601"/>
              </p:ext>
            </p:extLst>
          </p:nvPr>
        </p:nvGraphicFramePr>
        <p:xfrm>
          <a:off x="3884397" y="1379035"/>
          <a:ext cx="1587380" cy="3849404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587380">
                  <a:extLst>
                    <a:ext uri="{9D8B030D-6E8A-4147-A177-3AD203B41FA5}">
                      <a16:colId xmlns:a16="http://schemas.microsoft.com/office/drawing/2014/main" val="382952533"/>
                    </a:ext>
                  </a:extLst>
                </a:gridCol>
              </a:tblGrid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Genes</a:t>
                      </a:r>
                    </a:p>
                  </a:txBody>
                  <a:tcPr marL="1345" marR="1345" marT="13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141419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375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625189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bs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20485944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1117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494773806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fr47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964316023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tf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99215070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0830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40161362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1650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285007323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1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02330747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2c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519304866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59498403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97810287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rd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536265301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10004201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426973555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h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52855613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4477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88803930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27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57898481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k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94562673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rn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76895792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hadh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97868396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ep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26100242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pt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902718016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171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6545913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grl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1055488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m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929443616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511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95418001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cn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07241283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1h4i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04331012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o1c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15545116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tl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08760504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dc190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28408483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b-bs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631389087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10004244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99554049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x37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96378125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dn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67066744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192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40194432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ts2r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76084416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5a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397875343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10003990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79663154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1463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10209117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304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961383003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100041897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80657252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m4b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58618988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t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59663210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00a1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21625208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27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512694256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10086211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61571357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1031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525403840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10037I17Rik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81071668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dl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32920793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u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23208605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m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48392707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m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31886140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ekhb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90453282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087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47567461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n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417680012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e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45313887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hnyn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297321496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1800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65964234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dh17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83920952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pm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90344193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c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5047222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hlrc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31620135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eb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63629710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56444730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p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166627053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a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724064393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082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65014352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dr3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429166773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dc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278930053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1032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534510496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it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95091340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b-bt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01020217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opl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44251543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m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98861931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60787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52347401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kt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082218348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33407L21Rik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14270870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ml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761108225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0067P10Rik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243415166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brg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49836785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card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89407135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00a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72569799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bpl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53456745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9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04908183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dh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05262958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p4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429291836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ptl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412727483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x7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4008384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fr100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5645725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151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06721864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960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18996119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073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00228915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li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24801043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ms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414385762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884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47381335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sl2-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69399787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x2e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61953679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az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58948324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rsd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77502032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080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4260379210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10004227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600861410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10086222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91354495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dn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3306476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fp640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62034377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114a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81062825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mn1r20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047157436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194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92776869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15a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24651043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yr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34274160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173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88933405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6v0e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85567039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088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84729077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20917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89179609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1040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94323731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k1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422456563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bi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9380533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04867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96686368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e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04980238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spd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26060216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p2j1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127550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int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32614961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2d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83862504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al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16669221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k1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35382327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dl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96850036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nnbip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55355912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fr115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11505878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pg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66465906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rf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415936555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bp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49663595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a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99213036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3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79617776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c7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81018569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at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290288456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y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93863776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room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023797417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ak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557644173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730020M07Rik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794701676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hl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44832577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gdh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67029895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b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12423600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l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733859383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kscan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23337558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2afj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82655687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ssf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05346599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ms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689607496"/>
                  </a:ext>
                </a:extLst>
              </a:tr>
              <a:tr h="53008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10524292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884740825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h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92365541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bp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107090392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gfr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897686298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v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081466719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rx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89681938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hl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1714167150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3h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3330890814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om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/>
                </a:tc>
                <a:extLst>
                  <a:ext uri="{0D108BD9-81ED-4DB2-BD59-A6C34878D82A}">
                    <a16:rowId xmlns:a16="http://schemas.microsoft.com/office/drawing/2014/main" val="2887744021"/>
                  </a:ext>
                </a:extLst>
              </a:tr>
              <a:tr h="35877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mrp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45" marR="1345" marT="134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4942073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748A1DF-C145-1844-957B-BFC637C91F64}"/>
              </a:ext>
            </a:extLst>
          </p:cNvPr>
          <p:cNvSpPr txBox="1"/>
          <p:nvPr/>
        </p:nvSpPr>
        <p:spPr>
          <a:xfrm>
            <a:off x="479727" y="78047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C42B44A-8895-3541-8D64-6870043235C7}"/>
              </a:ext>
            </a:extLst>
          </p:cNvPr>
          <p:cNvSpPr txBox="1"/>
          <p:nvPr/>
        </p:nvSpPr>
        <p:spPr>
          <a:xfrm>
            <a:off x="3689472" y="78047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F378C1D3-2EF4-2A46-ACF1-106FEB85A2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9429491"/>
              </p:ext>
            </p:extLst>
          </p:nvPr>
        </p:nvGraphicFramePr>
        <p:xfrm>
          <a:off x="692143" y="1379035"/>
          <a:ext cx="1587381" cy="4069440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587381">
                  <a:extLst>
                    <a:ext uri="{9D8B030D-6E8A-4147-A177-3AD203B41FA5}">
                      <a16:colId xmlns:a16="http://schemas.microsoft.com/office/drawing/2014/main" val="3963791515"/>
                    </a:ext>
                  </a:extLst>
                </a:gridCol>
              </a:tblGrid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Genes</a:t>
                      </a:r>
                    </a:p>
                  </a:txBody>
                  <a:tcPr marL="1307" marR="1307" marT="13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746727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y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6765957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nc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05358870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t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40267117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fr115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48689798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tn4rl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5559861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bb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03289871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pr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91088170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f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80811643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j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86456115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gprx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38721677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p4e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90617038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k3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31198881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na1b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75817293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04854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36067205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ald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32775981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r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20346210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cat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03165027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as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72577829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tl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00874781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anp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29529717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v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4154307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rn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74538743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sp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41911280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in2c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47461975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em132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54751414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yn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27307206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ip5k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79082241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1d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31305884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prss7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312282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p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26554248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f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95664921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k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22517330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tv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06230715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4a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03357299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xndc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99565221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1c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33300320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rt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96025059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hlhe40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37915212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rs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84617291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em39b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89212655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fr103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84949994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fp69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68388276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fr59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99735743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3b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91221037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r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81952151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ed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15904497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tap9-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97489937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cor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93768073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grb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30342560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p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3412386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na1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24132996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62118285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dn34b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82822104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1091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05172718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oa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95479825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xo17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83726913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19a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86693446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mbp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38175337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mn2r8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99005189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stv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292611160"/>
                  </a:ext>
                </a:extLst>
              </a:tr>
              <a:tr h="51510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0007K09Rik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04605253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mn1r57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72044796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gp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45998945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o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02214202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dc12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26287882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mbpl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62927559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i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01864958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ser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65471096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bpl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19802212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xn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15812102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dr8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74014379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fb1i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1273402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gfb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59567838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na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61544985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se1l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77260493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10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800889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7a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17005959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49192149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ns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06375651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k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64195227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g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79073758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na1g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57365503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m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37799194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dm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73584850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fr122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2289694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br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41486274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ap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59357616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na1i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2253290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fr149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1804953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kn1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82335976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d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1108846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lnt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7403523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1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2010329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m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07846313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erg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33999425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4a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85156543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ger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08187591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rc6c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37771362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gf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67791085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13c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80205918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xdc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54560353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t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29559660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ud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9089038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lq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44009934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hgef1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71193617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rt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9378904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p2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14929507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174b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8591644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adm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46041385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l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63265769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lda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90958604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35c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78860613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3bgrl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7133682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04970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1878471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ar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447427736"/>
                  </a:ext>
                </a:extLst>
              </a:tr>
              <a:tr h="51510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33420G17Rik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39065960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f2d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99386997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gsl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69949796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rn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58709805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bp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82306554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ca4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8835283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ps9d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40239113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n1s2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2942701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3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01655306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2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88035607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kr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65083888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ice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42953480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pf1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570934328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m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3399589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ps37b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97742876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dhb1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37198976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gln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57602863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r1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56396226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vl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73612411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2a1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4115723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ib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30449538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po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29296903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k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20296113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77590749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o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75496835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fr1008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43197435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em20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25349885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65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702711034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ub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22377135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10845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516321817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030499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52532619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l7a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96437230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bp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54737212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x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78690634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iap2l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92784116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r3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09904026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rcd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86678394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mc6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96233960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1683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98126575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dec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3411882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fr47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141382878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t10a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17306311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as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307694012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mld1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5367416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ah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272636108"/>
                  </a:ext>
                </a:extLst>
              </a:tr>
              <a:tr h="51510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10035E14Rik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474304723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k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321229569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hk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315518880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mtk3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/>
                </a:tc>
                <a:extLst>
                  <a:ext uri="{0D108BD9-81ED-4DB2-BD59-A6C34878D82A}">
                    <a16:rowId xmlns:a16="http://schemas.microsoft.com/office/drawing/2014/main" val="2690260671"/>
                  </a:ext>
                </a:extLst>
              </a:tr>
              <a:tr h="34863">
                <a:tc>
                  <a:txBody>
                    <a:bodyPr/>
                    <a:lstStyle/>
                    <a:p>
                      <a:pPr algn="l" fontAlgn="ctr"/>
                      <a:r>
                        <a:rPr lang="en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048502</a:t>
                      </a:r>
                      <a:endParaRPr lang="en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1307" marR="1307" marT="13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71576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307539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" name="グラフ 1">
                <a:extLst>
                  <a:ext uri="{FF2B5EF4-FFF2-40B4-BE49-F238E27FC236}">
                    <a16:creationId xmlns:a16="http://schemas.microsoft.com/office/drawing/2014/main" id="{3F32743B-0B83-CE4C-8AFF-0C6BB10786FE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965234467"/>
                  </p:ext>
                </p:extLst>
              </p:nvPr>
            </p:nvGraphicFramePr>
            <p:xfrm>
              <a:off x="160541" y="675642"/>
              <a:ext cx="2606821" cy="223695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2" name="グラフ 1">
                <a:extLst>
                  <a:ext uri="{FF2B5EF4-FFF2-40B4-BE49-F238E27FC236}">
                    <a16:creationId xmlns:a16="http://schemas.microsoft.com/office/drawing/2014/main" id="{3F32743B-0B83-CE4C-8AFF-0C6BB10786FE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60541" y="675642"/>
                <a:ext cx="2606821" cy="2236954"/>
              </a:xfrm>
              <a:prstGeom prst="rect">
                <a:avLst/>
              </a:prstGeom>
            </p:spPr>
          </p:pic>
        </mc:Fallback>
      </mc:AlternateContent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CDD8F933-7D2F-EC10-469F-0CBF60B2F19C}"/>
              </a:ext>
            </a:extLst>
          </p:cNvPr>
          <p:cNvSpPr/>
          <p:nvPr/>
        </p:nvSpPr>
        <p:spPr>
          <a:xfrm>
            <a:off x="5528491" y="1525997"/>
            <a:ext cx="282388" cy="242047"/>
          </a:xfrm>
          <a:prstGeom prst="rect">
            <a:avLst/>
          </a:prstGeom>
          <a:solidFill>
            <a:srgbClr val="FF7E79">
              <a:alpha val="25102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24EA26D8-B3D8-2E86-9184-D7FE1F83FD49}"/>
              </a:ext>
            </a:extLst>
          </p:cNvPr>
          <p:cNvSpPr/>
          <p:nvPr/>
        </p:nvSpPr>
        <p:spPr>
          <a:xfrm>
            <a:off x="5528491" y="1121229"/>
            <a:ext cx="282388" cy="24204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259D4D60-B9AC-9985-8A69-5071CB8538D8}"/>
              </a:ext>
            </a:extLst>
          </p:cNvPr>
          <p:cNvSpPr/>
          <p:nvPr/>
        </p:nvSpPr>
        <p:spPr>
          <a:xfrm>
            <a:off x="5546421" y="1947337"/>
            <a:ext cx="282388" cy="242047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290221D-5D9A-351E-9C98-0D6D1D9A645F}"/>
              </a:ext>
            </a:extLst>
          </p:cNvPr>
          <p:cNvSpPr txBox="1"/>
          <p:nvPr/>
        </p:nvSpPr>
        <p:spPr>
          <a:xfrm>
            <a:off x="5845562" y="1057586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3656CFC-F111-1F84-0A18-B7CB664B7922}"/>
              </a:ext>
            </a:extLst>
          </p:cNvPr>
          <p:cNvSpPr txBox="1"/>
          <p:nvPr/>
        </p:nvSpPr>
        <p:spPr>
          <a:xfrm>
            <a:off x="5882701" y="1453812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D1A2E56-3DF9-0344-FCFB-8838837AB86A}"/>
              </a:ext>
            </a:extLst>
          </p:cNvPr>
          <p:cNvSpPr txBox="1"/>
          <p:nvPr/>
        </p:nvSpPr>
        <p:spPr>
          <a:xfrm>
            <a:off x="5859009" y="1850038"/>
            <a:ext cx="99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AB+YW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9" name="グラフ 8">
                <a:extLst>
                  <a:ext uri="{FF2B5EF4-FFF2-40B4-BE49-F238E27FC236}">
                    <a16:creationId xmlns:a16="http://schemas.microsoft.com/office/drawing/2014/main" id="{7466745D-DD7A-0148-BF11-1D8CF6CDC358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591398782"/>
                  </p:ext>
                </p:extLst>
              </p:nvPr>
            </p:nvGraphicFramePr>
            <p:xfrm>
              <a:off x="2839184" y="675642"/>
              <a:ext cx="2670175" cy="223695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4"/>
              </a:graphicData>
            </a:graphic>
          </p:graphicFrame>
        </mc:Choice>
        <mc:Fallback xmlns="">
          <p:pic>
            <p:nvPicPr>
              <p:cNvPr id="9" name="グラフ 8">
                <a:extLst>
                  <a:ext uri="{FF2B5EF4-FFF2-40B4-BE49-F238E27FC236}">
                    <a16:creationId xmlns:a16="http://schemas.microsoft.com/office/drawing/2014/main" id="{7466745D-DD7A-0148-BF11-1D8CF6CDC358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839184" y="675642"/>
                <a:ext cx="2670175" cy="2236954"/>
              </a:xfrm>
              <a:prstGeom prst="rect">
                <a:avLst/>
              </a:prstGeom>
            </p:spPr>
          </p:pic>
        </mc:Fallback>
      </mc:AlternateContent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ED50B69-417F-9DD1-15BD-6597A81E7495}"/>
              </a:ext>
            </a:extLst>
          </p:cNvPr>
          <p:cNvSpPr txBox="1"/>
          <p:nvPr/>
        </p:nvSpPr>
        <p:spPr>
          <a:xfrm>
            <a:off x="0" y="0"/>
            <a:ext cx="414408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1" name="グラフ 10">
                <a:extLst>
                  <a:ext uri="{FF2B5EF4-FFF2-40B4-BE49-F238E27FC236}">
                    <a16:creationId xmlns:a16="http://schemas.microsoft.com/office/drawing/2014/main" id="{273B2396-86A9-6A36-CCB9-E3E66CC202FB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362233062"/>
                  </p:ext>
                </p:extLst>
              </p:nvPr>
            </p:nvGraphicFramePr>
            <p:xfrm>
              <a:off x="255261" y="2770720"/>
              <a:ext cx="2480561" cy="223695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6"/>
              </a:graphicData>
            </a:graphic>
          </p:graphicFrame>
        </mc:Choice>
        <mc:Fallback xmlns="">
          <p:pic>
            <p:nvPicPr>
              <p:cNvPr id="11" name="グラフ 10">
                <a:extLst>
                  <a:ext uri="{FF2B5EF4-FFF2-40B4-BE49-F238E27FC236}">
                    <a16:creationId xmlns:a16="http://schemas.microsoft.com/office/drawing/2014/main" id="{273B2396-86A9-6A36-CCB9-E3E66CC202FB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55261" y="2770720"/>
                <a:ext cx="2480561" cy="2236954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2" name="グラフ 11">
                <a:extLst>
                  <a:ext uri="{FF2B5EF4-FFF2-40B4-BE49-F238E27FC236}">
                    <a16:creationId xmlns:a16="http://schemas.microsoft.com/office/drawing/2014/main" id="{9B130F2B-169B-887C-5686-BB24FEC7E8AD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059181244"/>
                  </p:ext>
                </p:extLst>
              </p:nvPr>
            </p:nvGraphicFramePr>
            <p:xfrm>
              <a:off x="3004130" y="2770720"/>
              <a:ext cx="2524362" cy="223695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8"/>
              </a:graphicData>
            </a:graphic>
          </p:graphicFrame>
        </mc:Choice>
        <mc:Fallback xmlns="">
          <p:pic>
            <p:nvPicPr>
              <p:cNvPr id="12" name="グラフ 11">
                <a:extLst>
                  <a:ext uri="{FF2B5EF4-FFF2-40B4-BE49-F238E27FC236}">
                    <a16:creationId xmlns:a16="http://schemas.microsoft.com/office/drawing/2014/main" id="{9B130F2B-169B-887C-5686-BB24FEC7E8AD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004130" y="2770720"/>
                <a:ext cx="2524362" cy="2236954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3" name="グラフ 12">
                <a:extLst>
                  <a:ext uri="{FF2B5EF4-FFF2-40B4-BE49-F238E27FC236}">
                    <a16:creationId xmlns:a16="http://schemas.microsoft.com/office/drawing/2014/main" id="{E7BC762C-FE49-BF87-F87A-68E6AE898535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957740485"/>
                  </p:ext>
                </p:extLst>
              </p:nvPr>
            </p:nvGraphicFramePr>
            <p:xfrm>
              <a:off x="212484" y="4843115"/>
              <a:ext cx="2566113" cy="223695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0"/>
              </a:graphicData>
            </a:graphic>
          </p:graphicFrame>
        </mc:Choice>
        <mc:Fallback xmlns="">
          <p:pic>
            <p:nvPicPr>
              <p:cNvPr id="13" name="グラフ 12">
                <a:extLst>
                  <a:ext uri="{FF2B5EF4-FFF2-40B4-BE49-F238E27FC236}">
                    <a16:creationId xmlns:a16="http://schemas.microsoft.com/office/drawing/2014/main" id="{E7BC762C-FE49-BF87-F87A-68E6AE898535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12484" y="4843115"/>
                <a:ext cx="2566113" cy="2236954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4" name="グラフ 13">
                <a:extLst>
                  <a:ext uri="{FF2B5EF4-FFF2-40B4-BE49-F238E27FC236}">
                    <a16:creationId xmlns:a16="http://schemas.microsoft.com/office/drawing/2014/main" id="{10231180-B0B8-97D9-5CFB-CE2913014553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944169946"/>
                  </p:ext>
                </p:extLst>
              </p:nvPr>
            </p:nvGraphicFramePr>
            <p:xfrm>
              <a:off x="2891214" y="4843115"/>
              <a:ext cx="2618145" cy="223695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2"/>
              </a:graphicData>
            </a:graphic>
          </p:graphicFrame>
        </mc:Choice>
        <mc:Fallback xmlns="">
          <p:pic>
            <p:nvPicPr>
              <p:cNvPr id="14" name="グラフ 13">
                <a:extLst>
                  <a:ext uri="{FF2B5EF4-FFF2-40B4-BE49-F238E27FC236}">
                    <a16:creationId xmlns:a16="http://schemas.microsoft.com/office/drawing/2014/main" id="{10231180-B0B8-97D9-5CFB-CE2913014553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2891214" y="4843115"/>
                <a:ext cx="2618145" cy="2236954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5" name="グラフ 14">
                <a:extLst>
                  <a:ext uri="{FF2B5EF4-FFF2-40B4-BE49-F238E27FC236}">
                    <a16:creationId xmlns:a16="http://schemas.microsoft.com/office/drawing/2014/main" id="{1951BF02-6AC2-9B24-936A-B57BFEF6EF16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169217915"/>
                  </p:ext>
                </p:extLst>
              </p:nvPr>
            </p:nvGraphicFramePr>
            <p:xfrm>
              <a:off x="1596136" y="6907046"/>
              <a:ext cx="2670175" cy="223695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4"/>
              </a:graphicData>
            </a:graphic>
          </p:graphicFrame>
        </mc:Choice>
        <mc:Fallback xmlns="">
          <p:pic>
            <p:nvPicPr>
              <p:cNvPr id="15" name="グラフ 14">
                <a:extLst>
                  <a:ext uri="{FF2B5EF4-FFF2-40B4-BE49-F238E27FC236}">
                    <a16:creationId xmlns:a16="http://schemas.microsoft.com/office/drawing/2014/main" id="{1951BF02-6AC2-9B24-936A-B57BFEF6EF16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596136" y="6907046"/>
                <a:ext cx="2670175" cy="2236954"/>
              </a:xfrm>
              <a:prstGeom prst="rect">
                <a:avLst/>
              </a:prstGeom>
            </p:spPr>
          </p:pic>
        </mc:Fallback>
      </mc:AlternateContent>
    </p:spTree>
    <p:extLst>
      <p:ext uri="{BB962C8B-B14F-4D97-AF65-F5344CB8AC3E}">
        <p14:creationId xmlns:p14="http://schemas.microsoft.com/office/powerpoint/2010/main" val="33520577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56DA2D6-B000-2F63-91EB-FA8C4F1562C1}"/>
              </a:ext>
            </a:extLst>
          </p:cNvPr>
          <p:cNvSpPr txBox="1"/>
          <p:nvPr/>
        </p:nvSpPr>
        <p:spPr>
          <a:xfrm>
            <a:off x="0" y="0"/>
            <a:ext cx="414408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709457F6-EE04-4714-B23F-6F4E3F520EF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933" t="20358" r="63943" b="14337"/>
          <a:stretch/>
        </p:blipFill>
        <p:spPr>
          <a:xfrm>
            <a:off x="1288415" y="1035367"/>
            <a:ext cx="4545965" cy="2771775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5EDBFB6-4061-4503-9C0E-52707817C25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00" t="24651" r="63929" b="9417"/>
          <a:stretch/>
        </p:blipFill>
        <p:spPr>
          <a:xfrm>
            <a:off x="1288415" y="4080827"/>
            <a:ext cx="4546600" cy="2794000"/>
          </a:xfrm>
          <a:prstGeom prst="rect">
            <a:avLst/>
          </a:prstGeom>
        </p:spPr>
      </p:pic>
      <p:sp>
        <p:nvSpPr>
          <p:cNvPr id="5" name="テキスト ボックス 3">
            <a:extLst>
              <a:ext uri="{FF2B5EF4-FFF2-40B4-BE49-F238E27FC236}">
                <a16:creationId xmlns:a16="http://schemas.microsoft.com/office/drawing/2014/main" id="{E9BEFF9D-727E-4206-A7E5-04140F0FBAE0}"/>
              </a:ext>
            </a:extLst>
          </p:cNvPr>
          <p:cNvSpPr txBox="1"/>
          <p:nvPr/>
        </p:nvSpPr>
        <p:spPr>
          <a:xfrm>
            <a:off x="1077595" y="634047"/>
            <a:ext cx="335915" cy="5486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800" kern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A</a:t>
            </a:r>
            <a:endParaRPr lang="ja-JP" sz="105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4">
            <a:extLst>
              <a:ext uri="{FF2B5EF4-FFF2-40B4-BE49-F238E27FC236}">
                <a16:creationId xmlns:a16="http://schemas.microsoft.com/office/drawing/2014/main" id="{2E4705D3-B319-4F69-AD6C-673419088D0C}"/>
              </a:ext>
            </a:extLst>
          </p:cNvPr>
          <p:cNvSpPr txBox="1"/>
          <p:nvPr/>
        </p:nvSpPr>
        <p:spPr>
          <a:xfrm>
            <a:off x="1077595" y="3704272"/>
            <a:ext cx="335915" cy="5486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800" kern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B</a:t>
            </a:r>
            <a:endParaRPr lang="ja-JP" sz="105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5">
            <a:extLst>
              <a:ext uri="{FF2B5EF4-FFF2-40B4-BE49-F238E27FC236}">
                <a16:creationId xmlns:a16="http://schemas.microsoft.com/office/drawing/2014/main" id="{C7B39D0F-2DF7-46A1-8F22-D5C0FDD0D8E0}"/>
              </a:ext>
            </a:extLst>
          </p:cNvPr>
          <p:cNvSpPr txBox="1"/>
          <p:nvPr/>
        </p:nvSpPr>
        <p:spPr>
          <a:xfrm>
            <a:off x="347980" y="7046912"/>
            <a:ext cx="616204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Supplementary Fig.S2. Representative MS chromatograms of Tyr-</a:t>
            </a:r>
            <a:r>
              <a:rPr lang="en-US" sz="14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Trp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standard (A) and Tyr-</a:t>
            </a:r>
            <a:r>
              <a:rPr lang="en-US" sz="14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Trp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in an edible soy peptide (B). HPLC-MS/MS analysis of Tyr-</a:t>
            </a:r>
            <a:r>
              <a:rPr lang="en-US" sz="14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Trp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in a commercially available soy peptide mixture (</a:t>
            </a:r>
            <a:r>
              <a:rPr lang="en-US" sz="14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Hinute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-AM, Fuji Oil Co., Japan [6]) was conducted with the </a:t>
            </a:r>
            <a:r>
              <a:rPr lang="en-US" sz="14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Nexera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X2 system (Shimadzu Corp., Kyoto, Japan) equipped with LCMS-8050 triple quadrupole mass spectrometer (Shimadzu Corp.). The analytical column (</a:t>
            </a:r>
            <a:r>
              <a:rPr lang="en-US" sz="14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Inertsustain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 swift C18, </a:t>
            </a:r>
            <a:r>
              <a:rPr lang="el-GR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φ2.1×150 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m, 3</a:t>
            </a:r>
            <a:r>
              <a:rPr lang="el-GR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μ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" panose="020B0400000000000000" pitchFamily="34" charset="-128"/>
                <a:cs typeface="Times New Roman" panose="02020603050405020304" pitchFamily="18" charset="0"/>
              </a:rPr>
              <a:t>m) was used. MRM conditions were 368.40&gt;136.15 and 368.40&gt;205.15.</a:t>
            </a:r>
            <a:endParaRPr 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64232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547</TotalTime>
  <Words>501</Words>
  <Application>Microsoft Office PowerPoint</Application>
  <PresentationFormat>On-screen Show (4:3)</PresentationFormat>
  <Paragraphs>34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2" baseType="lpstr">
      <vt:lpstr>游ゴシック</vt:lpstr>
      <vt:lpstr>游明朝</vt:lpstr>
      <vt:lpstr>Arial</vt:lpstr>
      <vt:lpstr>Calibri</vt:lpstr>
      <vt:lpstr>Calibri Light</vt:lpstr>
      <vt:lpstr>Helvetica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DPI</cp:lastModifiedBy>
  <cp:revision>225</cp:revision>
  <cp:lastPrinted>2021-01-04T04:21:57Z</cp:lastPrinted>
  <dcterms:created xsi:type="dcterms:W3CDTF">2020-03-10T05:18:41Z</dcterms:created>
  <dcterms:modified xsi:type="dcterms:W3CDTF">2023-06-13T04:16:42Z</dcterms:modified>
</cp:coreProperties>
</file>